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59" r:id="rId4"/>
    <p:sldId id="257" r:id="rId5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1518" y="1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77986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33627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22812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8001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0267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5934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89589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6329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56646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49113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580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19058-C1CB-4A76-91E6-0B9D7F490DA2}" type="datetimeFigureOut">
              <a:rPr lang="nl-NL" smtClean="0"/>
              <a:t>7-5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BEAF3-1A10-4CCC-A9E5-0B6FFEEABE23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72449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5397" y="764853"/>
            <a:ext cx="873750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Urinary Potassium Excretion and Mortality Risk in Community-Dwelling Individuals with and without </a:t>
            </a:r>
            <a:r>
              <a:rPr lang="en-US" sz="1400" b="1" dirty="0" smtClean="0"/>
              <a:t>obesity</a:t>
            </a:r>
          </a:p>
          <a:p>
            <a:r>
              <a:rPr lang="en-US" sz="1400" dirty="0" smtClean="0"/>
              <a:t>Yeung et al. </a:t>
            </a:r>
          </a:p>
          <a:p>
            <a:r>
              <a:rPr lang="nl-NL" sz="1400" dirty="0" smtClean="0"/>
              <a:t>Online </a:t>
            </a:r>
            <a:r>
              <a:rPr lang="nl-NL" sz="1400" dirty="0" err="1"/>
              <a:t>Supplementary</a:t>
            </a:r>
            <a:r>
              <a:rPr lang="nl-NL" sz="1400" dirty="0"/>
              <a:t> </a:t>
            </a:r>
            <a:r>
              <a:rPr lang="nl-NL" sz="1400" dirty="0" err="1" smtClean="0"/>
              <a:t>Material</a:t>
            </a:r>
            <a:r>
              <a:rPr lang="nl-NL" sz="1400" dirty="0" smtClean="0"/>
              <a:t> – Supplemental </a:t>
            </a:r>
            <a:r>
              <a:rPr lang="nl-NL" sz="1400" dirty="0" err="1" smtClean="0"/>
              <a:t>figures</a:t>
            </a:r>
            <a:endParaRPr lang="nl-NL" sz="1400" b="1" dirty="0"/>
          </a:p>
        </p:txBody>
      </p:sp>
    </p:spTree>
    <p:extLst>
      <p:ext uri="{BB962C8B-B14F-4D97-AF65-F5344CB8AC3E}">
        <p14:creationId xmlns:p14="http://schemas.microsoft.com/office/powerpoint/2010/main" val="39613283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260" y="620689"/>
            <a:ext cx="1944216" cy="715089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,768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inary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bumi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cretio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≥10mg/L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ited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18031" y="620688"/>
            <a:ext cx="2004640" cy="715089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,395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inary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bumi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cretio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&lt;10mg/L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ited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33137" y="1992435"/>
            <a:ext cx="1974428" cy="510778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,592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ritte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sent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55158" y="1992435"/>
            <a:ext cx="1902420" cy="510778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,000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ritten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sent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14617" y="3177470"/>
            <a:ext cx="1614388" cy="510778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592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let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aseline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05087" y="5023925"/>
            <a:ext cx="1833447" cy="510778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,533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rent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226043" y="4120296"/>
            <a:ext cx="1728192" cy="510778"/>
          </a:xfrm>
          <a:prstGeom prst="round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9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llect 24-hour urine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/>
          <p:cNvCxnSpPr>
            <a:stCxn id="5" idx="2"/>
            <a:endCxn id="6" idx="0"/>
          </p:cNvCxnSpPr>
          <p:nvPr/>
        </p:nvCxnSpPr>
        <p:spPr>
          <a:xfrm>
            <a:off x="2120351" y="1335777"/>
            <a:ext cx="0" cy="656658"/>
          </a:xfrm>
          <a:prstGeom prst="line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>
            <a:stCxn id="4" idx="2"/>
            <a:endCxn id="7" idx="0"/>
          </p:cNvCxnSpPr>
          <p:nvPr/>
        </p:nvCxnSpPr>
        <p:spPr>
          <a:xfrm>
            <a:off x="6006368" y="1335778"/>
            <a:ext cx="0" cy="656657"/>
          </a:xfrm>
          <a:prstGeom prst="line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lbow Connector 26"/>
          <p:cNvCxnSpPr>
            <a:stCxn id="6" idx="3"/>
            <a:endCxn id="8" idx="0"/>
          </p:cNvCxnSpPr>
          <p:nvPr/>
        </p:nvCxnSpPr>
        <p:spPr>
          <a:xfrm>
            <a:off x="3107565" y="2247824"/>
            <a:ext cx="1014246" cy="929646"/>
          </a:xfrm>
          <a:prstGeom prst="bentConnector2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7" idx="1"/>
            <a:endCxn id="8" idx="0"/>
          </p:cNvCxnSpPr>
          <p:nvPr/>
        </p:nvCxnSpPr>
        <p:spPr>
          <a:xfrm rot="10800000" flipV="1">
            <a:off x="4121812" y="2247824"/>
            <a:ext cx="933347" cy="929646"/>
          </a:xfrm>
          <a:prstGeom prst="bentConnector2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>
            <a:stCxn id="8" idx="2"/>
            <a:endCxn id="9" idx="0"/>
          </p:cNvCxnSpPr>
          <p:nvPr/>
        </p:nvCxnSpPr>
        <p:spPr>
          <a:xfrm>
            <a:off x="4121811" y="3688248"/>
            <a:ext cx="0" cy="1335677"/>
          </a:xfrm>
          <a:prstGeom prst="line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>
            <a:stCxn id="10" idx="3"/>
          </p:cNvCxnSpPr>
          <p:nvPr/>
        </p:nvCxnSpPr>
        <p:spPr>
          <a:xfrm>
            <a:off x="2954235" y="4375685"/>
            <a:ext cx="1186379" cy="0"/>
          </a:xfrm>
          <a:prstGeom prst="line">
            <a:avLst/>
          </a:prstGeom>
          <a:ln w="285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7380313" y="6563790"/>
            <a:ext cx="176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err="1" smtClean="0"/>
              <a:t>Supplementary</a:t>
            </a:r>
            <a:r>
              <a:rPr lang="nl-NL" sz="1200" dirty="0" smtClean="0"/>
              <a:t> </a:t>
            </a:r>
            <a:r>
              <a:rPr lang="nl-NL" sz="1200" dirty="0" err="1" smtClean="0"/>
              <a:t>figure</a:t>
            </a:r>
            <a:r>
              <a:rPr lang="nl-NL" sz="1200" dirty="0" smtClean="0"/>
              <a:t> 1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2586424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05001"/>
            <a:ext cx="8820472" cy="651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452321" y="6593914"/>
            <a:ext cx="169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err="1" smtClean="0"/>
              <a:t>Supplementary</a:t>
            </a:r>
            <a:r>
              <a:rPr lang="nl-NL" sz="1200" dirty="0" smtClean="0"/>
              <a:t> </a:t>
            </a:r>
            <a:r>
              <a:rPr lang="nl-NL" sz="1200" dirty="0" err="1" smtClean="0"/>
              <a:t>figure</a:t>
            </a:r>
            <a:r>
              <a:rPr lang="nl-NL" sz="1200" dirty="0" smtClean="0"/>
              <a:t> 2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405783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yeungmh\AppData\Local\Microsoft\Windows\Temporary Internet Files\Content.Outlook\3AEKUKTM\Schermafbeelding 2022-02-18 om 17.05.38 (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1419624"/>
            <a:ext cx="4499992" cy="40976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yeungmh\AppData\Local\Microsoft\Windows\Temporary Internet Files\Content.Outlook\3AEKUKTM\Schermafbeelding 2022-02-18 om 17.04.59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419624"/>
            <a:ext cx="4508041" cy="40976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635896" y="15567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A</a:t>
            </a:r>
            <a:endParaRPr lang="nl-NL" dirty="0"/>
          </a:p>
        </p:txBody>
      </p:sp>
      <p:sp>
        <p:nvSpPr>
          <p:cNvPr id="7" name="TextBox 6"/>
          <p:cNvSpPr txBox="1"/>
          <p:nvPr/>
        </p:nvSpPr>
        <p:spPr>
          <a:xfrm>
            <a:off x="8316416" y="1561471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B</a:t>
            </a:r>
            <a:endParaRPr lang="nl-NL" dirty="0"/>
          </a:p>
        </p:txBody>
      </p:sp>
      <p:sp>
        <p:nvSpPr>
          <p:cNvPr id="6" name="TextBox 5"/>
          <p:cNvSpPr txBox="1"/>
          <p:nvPr/>
        </p:nvSpPr>
        <p:spPr>
          <a:xfrm>
            <a:off x="7452320" y="6572179"/>
            <a:ext cx="169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err="1" smtClean="0"/>
              <a:t>Supplementary</a:t>
            </a:r>
            <a:r>
              <a:rPr lang="nl-NL" sz="1200" dirty="0" smtClean="0"/>
              <a:t> </a:t>
            </a:r>
            <a:r>
              <a:rPr lang="nl-NL" sz="1200" dirty="0" err="1" smtClean="0"/>
              <a:t>figure</a:t>
            </a:r>
            <a:r>
              <a:rPr lang="nl-NL" sz="1200" dirty="0" smtClean="0"/>
              <a:t> 3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2087107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On-screen Show (4:3)</PresentationFormat>
  <Paragraphs>1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air Medisch Centrum Gron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ung, MH</dc:creator>
  <cp:lastModifiedBy>Yeung, MH </cp:lastModifiedBy>
  <cp:revision>3</cp:revision>
  <dcterms:created xsi:type="dcterms:W3CDTF">2022-02-18T17:46:27Z</dcterms:created>
  <dcterms:modified xsi:type="dcterms:W3CDTF">2022-05-07T16:44:19Z</dcterms:modified>
</cp:coreProperties>
</file>